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0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88" autoAdjust="0"/>
    <p:restoredTop sz="95631" autoAdjust="0"/>
  </p:normalViewPr>
  <p:slideViewPr>
    <p:cSldViewPr snapToGrid="0">
      <p:cViewPr varScale="1">
        <p:scale>
          <a:sx n="71" d="100"/>
          <a:sy n="71" d="100"/>
        </p:scale>
        <p:origin x="34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205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57E124-7984-47DF-9DB3-96261744DEE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A1D031-33C9-4BD1-86F3-2A3FA351121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4920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59409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0580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3730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6844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0483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2628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72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7301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1004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0430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6953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023C0-FC84-4236-83BA-364191644CDB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D3791-3E9E-49AF-9061-C098F9C6F38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1368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B04D2E46-0F7F-5DC7-95F4-76237A9ACD1F}"/>
              </a:ext>
            </a:extLst>
          </p:cNvPr>
          <p:cNvGrpSpPr/>
          <p:nvPr/>
        </p:nvGrpSpPr>
        <p:grpSpPr>
          <a:xfrm>
            <a:off x="3861988" y="475577"/>
            <a:ext cx="2923223" cy="9058149"/>
            <a:chOff x="4061562" y="475577"/>
            <a:chExt cx="2923223" cy="9058149"/>
          </a:xfrm>
        </p:grpSpPr>
        <p:pic>
          <p:nvPicPr>
            <p:cNvPr id="4" name="Graphic 3">
              <a:extLst>
                <a:ext uri="{FF2B5EF4-FFF2-40B4-BE49-F238E27FC236}">
                  <a16:creationId xmlns:a16="http://schemas.microsoft.com/office/drawing/2014/main" id="{F093D830-472D-0D76-6326-2BE8F6F53D3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t="2045"/>
            <a:stretch>
              <a:fillRect/>
            </a:stretch>
          </p:blipFill>
          <p:spPr>
            <a:xfrm>
              <a:off x="4061562" y="964391"/>
              <a:ext cx="2923223" cy="8569335"/>
            </a:xfrm>
            <a:prstGeom prst="rect">
              <a:avLst/>
            </a:prstGeom>
          </p:spPr>
        </p:pic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CA6E48FE-F4DD-837A-E013-907898729B2B}"/>
                </a:ext>
              </a:extLst>
            </p:cNvPr>
            <p:cNvGrpSpPr/>
            <p:nvPr/>
          </p:nvGrpSpPr>
          <p:grpSpPr>
            <a:xfrm>
              <a:off x="4121057" y="475577"/>
              <a:ext cx="2112497" cy="488814"/>
              <a:chOff x="3802609" y="475577"/>
              <a:chExt cx="2112497" cy="488814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88B45345-094F-DCF7-ACA9-1DE828D0B476}"/>
                  </a:ext>
                </a:extLst>
              </p:cNvPr>
              <p:cNvSpPr txBox="1"/>
              <p:nvPr/>
            </p:nvSpPr>
            <p:spPr>
              <a:xfrm>
                <a:off x="3802609" y="561109"/>
                <a:ext cx="30489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lang="en-IN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0D5EE60-A90E-EAAD-99DF-71BBBD2278D7}"/>
                  </a:ext>
                </a:extLst>
              </p:cNvPr>
              <p:cNvSpPr txBox="1"/>
              <p:nvPr/>
            </p:nvSpPr>
            <p:spPr>
              <a:xfrm>
                <a:off x="5655098" y="561109"/>
                <a:ext cx="2600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IN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BB7E6C1-85CE-694D-1216-99661626046C}"/>
                  </a:ext>
                </a:extLst>
              </p:cNvPr>
              <p:cNvSpPr txBox="1"/>
              <p:nvPr/>
            </p:nvSpPr>
            <p:spPr>
              <a:xfrm>
                <a:off x="4544818" y="733559"/>
                <a:ext cx="6591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og2 fold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88116C2B-038E-7A1B-D070-1CFD8E5C071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949714" y="475577"/>
                <a:ext cx="1849362" cy="137438"/>
              </a:xfrm>
              <a:prstGeom prst="rect">
                <a:avLst/>
              </a:prstGeom>
              <a:gradFill>
                <a:gsLst>
                  <a:gs pos="0">
                    <a:srgbClr val="B35806"/>
                  </a:gs>
                  <a:gs pos="50000">
                    <a:schemeClr val="bg1"/>
                  </a:gs>
                  <a:gs pos="100000">
                    <a:srgbClr val="542788"/>
                  </a:gs>
                </a:gsLst>
                <a:lin ang="206018" scaled="1"/>
              </a:gradFill>
              <a:ln w="10160">
                <a:solidFill>
                  <a:srgbClr val="40808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3291564-B420-EAB4-532C-F0AE633938CB}"/>
                  </a:ext>
                </a:extLst>
              </p:cNvPr>
              <p:cNvSpPr txBox="1"/>
              <p:nvPr/>
            </p:nvSpPr>
            <p:spPr>
              <a:xfrm>
                <a:off x="4831131" y="561109"/>
                <a:ext cx="8652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IN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74685250-1052-25F4-2B44-F4C7B2A3F389}"/>
              </a:ext>
            </a:extLst>
          </p:cNvPr>
          <p:cNvSpPr txBox="1"/>
          <p:nvPr/>
        </p:nvSpPr>
        <p:spPr>
          <a:xfrm>
            <a:off x="236017" y="3364476"/>
            <a:ext cx="3498856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tabolite profiles of different organ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. The relative level of metabolites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plants was calculated using AC as a control plant for Seedling, Root, Leaf, and Floral bud; and Chatham as a control plant for Red Ripe fruit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lative changes in the metabolite levels were determined by calculating the log2 fold change with respect to the respective control. Only significantly changed metabolites, with reference to AC/Chatham, are depicted (Log2 fold ≥ ± 0.584, p-value ≤ 0.05, 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). Fo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ake of convenience, a consolidated control (AC/Chatham) for all samples is shown at the left of the heatmap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Dataset S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 levels and significance.</a:t>
            </a:r>
          </a:p>
        </p:txBody>
      </p:sp>
    </p:spTree>
    <p:extLst>
      <p:ext uri="{BB962C8B-B14F-4D97-AF65-F5344CB8AC3E}">
        <p14:creationId xmlns:p14="http://schemas.microsoft.com/office/powerpoint/2010/main" val="8451504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022</TotalTime>
  <Words>143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meshwar Sharma</dc:creator>
  <cp:lastModifiedBy>Rameshwar Sharma</cp:lastModifiedBy>
  <cp:revision>35</cp:revision>
  <dcterms:created xsi:type="dcterms:W3CDTF">2025-06-16T09:20:07Z</dcterms:created>
  <dcterms:modified xsi:type="dcterms:W3CDTF">2026-01-03T07:33:55Z</dcterms:modified>
</cp:coreProperties>
</file>